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04" r:id="rId2"/>
    <p:sldId id="286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3"/>
  </p:normalViewPr>
  <p:slideViewPr>
    <p:cSldViewPr snapToGrid="0">
      <p:cViewPr varScale="1">
        <p:scale>
          <a:sx n="86" d="100"/>
          <a:sy n="86" d="100"/>
        </p:scale>
        <p:origin x="355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049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124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001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93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833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649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421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082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597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354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72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B7BEC14-D725-D448-84C6-E4E8CD957781}" type="datetimeFigureOut">
              <a:rPr lang="en-US" smtClean="0"/>
              <a:t>1/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81A305-2C4D-6249-9BD8-67441486F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547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7D8F881-4B4F-DCB8-5BB6-C29BC7A59BD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9595" y="1069727"/>
          <a:ext cx="6160412" cy="70293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8737600" imgH="9969500" progId="Excel.Sheet.12">
                  <p:embed/>
                </p:oleObj>
              </mc:Choice>
              <mc:Fallback>
                <p:oleObj name="Worksheet" r:id="rId2" imgW="8737600" imgH="9969500" progId="Excel.Sheet.12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D7D8F881-4B4F-DCB8-5BB6-C29BC7A59B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9595" y="1069727"/>
                        <a:ext cx="6160412" cy="70293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F79706D-36B5-62E1-D6F5-168053397514}"/>
              </a:ext>
            </a:extLst>
          </p:cNvPr>
          <p:cNvSpPr txBox="1"/>
          <p:nvPr/>
        </p:nvSpPr>
        <p:spPr>
          <a:xfrm>
            <a:off x="1403891" y="210585"/>
            <a:ext cx="4071820" cy="336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88" b="1" dirty="0"/>
              <a:t>Supplementary Table 1</a:t>
            </a:r>
            <a:r>
              <a:rPr lang="en-US" sz="1588" dirty="0"/>
              <a:t>.  PCR primers used.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1ED858A7-C03B-8A24-C91A-35F8E60CE652}"/>
              </a:ext>
            </a:extLst>
          </p:cNvPr>
          <p:cNvCxnSpPr>
            <a:cxnSpLocks/>
          </p:cNvCxnSpPr>
          <p:nvPr/>
        </p:nvCxnSpPr>
        <p:spPr>
          <a:xfrm>
            <a:off x="345703" y="877160"/>
            <a:ext cx="617430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703812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97F112-A4BA-A4F3-5CE3-987CFFB4FE5F}"/>
              </a:ext>
            </a:extLst>
          </p:cNvPr>
          <p:cNvSpPr txBox="1"/>
          <p:nvPr/>
        </p:nvSpPr>
        <p:spPr>
          <a:xfrm>
            <a:off x="1134907" y="311968"/>
            <a:ext cx="4522769" cy="581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88" b="1" dirty="0"/>
              <a:t>Supplementary Table 2. </a:t>
            </a:r>
            <a:r>
              <a:rPr lang="en-US" sz="1588" dirty="0"/>
              <a:t>Patient clinical parameters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65110A47-AB8B-3845-5941-95DE8849DAE2}"/>
              </a:ext>
            </a:extLst>
          </p:cNvPr>
          <p:cNvGrpSpPr/>
          <p:nvPr/>
        </p:nvGrpSpPr>
        <p:grpSpPr>
          <a:xfrm>
            <a:off x="71186" y="1211467"/>
            <a:ext cx="6715629" cy="5571444"/>
            <a:chOff x="80677" y="1235676"/>
            <a:chExt cx="7611046" cy="6314303"/>
          </a:xfrm>
        </p:grpSpPr>
        <p:pic>
          <p:nvPicPr>
            <p:cNvPr id="1025" name="Picture 1" descr="page1image2593248">
              <a:extLst>
                <a:ext uri="{FF2B5EF4-FFF2-40B4-BE49-F238E27FC236}">
                  <a16:creationId xmlns:a16="http://schemas.microsoft.com/office/drawing/2014/main" id="{19300D14-26FD-CCA1-E44E-4415D034E04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677" y="1248033"/>
              <a:ext cx="7611046" cy="63019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F8DEAC8-B3EA-A5FD-7E56-9E4A316D8D8C}"/>
                </a:ext>
              </a:extLst>
            </p:cNvPr>
            <p:cNvSpPr txBox="1"/>
            <p:nvPr/>
          </p:nvSpPr>
          <p:spPr>
            <a:xfrm>
              <a:off x="7252433" y="1235676"/>
              <a:ext cx="309210" cy="320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35" b="1" dirty="0"/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6D7A94D-C71B-4F80-ADAD-127685071905}"/>
                </a:ext>
              </a:extLst>
            </p:cNvPr>
            <p:cNvSpPr txBox="1"/>
            <p:nvPr/>
          </p:nvSpPr>
          <p:spPr>
            <a:xfrm>
              <a:off x="1051304" y="5635937"/>
              <a:ext cx="314659" cy="320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35" b="1" dirty="0"/>
                <a:t>b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9CC2A37-F182-C52F-820D-CA58EEA2B366}"/>
              </a:ext>
            </a:extLst>
          </p:cNvPr>
          <p:cNvSpPr txBox="1"/>
          <p:nvPr/>
        </p:nvSpPr>
        <p:spPr>
          <a:xfrm>
            <a:off x="75042" y="6782911"/>
            <a:ext cx="6642498" cy="852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65" b="1" baseline="30000" dirty="0" err="1"/>
              <a:t>a</a:t>
            </a:r>
            <a:r>
              <a:rPr lang="en-US" sz="1235" dirty="0" err="1"/>
              <a:t>Students</a:t>
            </a:r>
            <a:r>
              <a:rPr lang="en-US" sz="1235" dirty="0"/>
              <a:t> t-test, Wilcoxon test, or Fisher’s Exact test were utilized for normally distributed variables, non-normal variables and categorical variables respectively. p&lt;0.05 was considered statistically significant.</a:t>
            </a:r>
          </a:p>
          <a:p>
            <a:r>
              <a:rPr lang="en-US" sz="1765" b="1" baseline="30000" dirty="0" err="1"/>
              <a:t>b</a:t>
            </a:r>
            <a:r>
              <a:rPr lang="en-US" sz="1235" dirty="0" err="1"/>
              <a:t>External</a:t>
            </a:r>
            <a:r>
              <a:rPr lang="en-US" sz="1235" dirty="0"/>
              <a:t> beam radiotherapy (EBRT) and brachytherapy (brachy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7F1A4F3D-4821-30CC-F706-03179983D800}"/>
              </a:ext>
            </a:extLst>
          </p:cNvPr>
          <p:cNvCxnSpPr>
            <a:cxnSpLocks/>
          </p:cNvCxnSpPr>
          <p:nvPr/>
        </p:nvCxnSpPr>
        <p:spPr>
          <a:xfrm>
            <a:off x="247071" y="982399"/>
            <a:ext cx="636385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7746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0</Words>
  <Application>Microsoft Macintosh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Workshee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 Van Arsdale</dc:creator>
  <cp:lastModifiedBy>Anne Van Arsdale</cp:lastModifiedBy>
  <cp:revision>1</cp:revision>
  <dcterms:created xsi:type="dcterms:W3CDTF">2025-01-06T20:22:56Z</dcterms:created>
  <dcterms:modified xsi:type="dcterms:W3CDTF">2025-01-06T20:24:21Z</dcterms:modified>
</cp:coreProperties>
</file>